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 id="257" r:id="rId3"/>
    <p:sldId id="258" r:id="rId4"/>
    <p:sldId id="259" r:id="rId5"/>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FBF9D44-1B72-4F40-A342-EC98FBDA410D}" v="16" dt="2026-01-07T18:27:08.14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p:scale>
          <a:sx n="160" d="100"/>
          <a:sy n="160" d="100"/>
        </p:scale>
        <p:origin x="398" y="-48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ian Gourdeau" userId="3ac40c24-6cc4-4d51-8833-f135e277a828" providerId="ADAL" clId="{8B93CD47-A855-419C-90B7-815DDE89D493}"/>
    <pc:docChg chg="undo custSel addSld delSld modSld">
      <pc:chgData name="Christian Gourdeau" userId="3ac40c24-6cc4-4d51-8833-f135e277a828" providerId="ADAL" clId="{8B93CD47-A855-419C-90B7-815DDE89D493}" dt="2026-01-08T13:19:00.686" v="180" actId="20577"/>
      <pc:docMkLst>
        <pc:docMk/>
      </pc:docMkLst>
      <pc:sldChg chg="addSp delSp modSp mod">
        <pc:chgData name="Christian Gourdeau" userId="3ac40c24-6cc4-4d51-8833-f135e277a828" providerId="ADAL" clId="{8B93CD47-A855-419C-90B7-815DDE89D493}" dt="2026-01-08T13:19:00.686" v="180" actId="20577"/>
        <pc:sldMkLst>
          <pc:docMk/>
          <pc:sldMk cId="1587328182" sldId="256"/>
        </pc:sldMkLst>
        <pc:spChg chg="del mod">
          <ac:chgData name="Christian Gourdeau" userId="3ac40c24-6cc4-4d51-8833-f135e277a828" providerId="ADAL" clId="{8B93CD47-A855-419C-90B7-815DDE89D493}" dt="2026-01-07T18:00:13.764" v="55"/>
          <ac:spMkLst>
            <pc:docMk/>
            <pc:sldMk cId="1587328182" sldId="256"/>
            <ac:spMk id="3" creationId="{3EC9A2DB-5304-E657-9763-8E34518447E0}"/>
          </ac:spMkLst>
        </pc:spChg>
        <pc:spChg chg="add mod">
          <ac:chgData name="Christian Gourdeau" userId="3ac40c24-6cc4-4d51-8833-f135e277a828" providerId="ADAL" clId="{8B93CD47-A855-419C-90B7-815DDE89D493}" dt="2026-01-07T18:34:29.407" v="178" actId="14100"/>
          <ac:spMkLst>
            <pc:docMk/>
            <pc:sldMk cId="1587328182" sldId="256"/>
            <ac:spMk id="3" creationId="{D87B4501-D7BF-A9EB-E9F7-5BA320F08A2A}"/>
          </ac:spMkLst>
        </pc:spChg>
        <pc:spChg chg="add mod">
          <ac:chgData name="Christian Gourdeau" userId="3ac40c24-6cc4-4d51-8833-f135e277a828" providerId="ADAL" clId="{8B93CD47-A855-419C-90B7-815DDE89D493}" dt="2026-01-08T13:19:00.686" v="180" actId="20577"/>
          <ac:spMkLst>
            <pc:docMk/>
            <pc:sldMk cId="1587328182" sldId="256"/>
            <ac:spMk id="5" creationId="{9CF90590-1DDF-739A-1C66-9C954959BA84}"/>
          </ac:spMkLst>
        </pc:spChg>
        <pc:spChg chg="mod">
          <ac:chgData name="Christian Gourdeau" userId="3ac40c24-6cc4-4d51-8833-f135e277a828" providerId="ADAL" clId="{8B93CD47-A855-419C-90B7-815DDE89D493}" dt="2026-01-07T18:32:54.709" v="169" actId="1035"/>
          <ac:spMkLst>
            <pc:docMk/>
            <pc:sldMk cId="1587328182" sldId="256"/>
            <ac:spMk id="6" creationId="{66A20D97-D575-60D6-5C64-CBF0599F2F52}"/>
          </ac:spMkLst>
        </pc:spChg>
        <pc:spChg chg="del mod">
          <ac:chgData name="Christian Gourdeau" userId="3ac40c24-6cc4-4d51-8833-f135e277a828" providerId="ADAL" clId="{8B93CD47-A855-419C-90B7-815DDE89D493}" dt="2026-01-07T17:48:08.264" v="2" actId="478"/>
          <ac:spMkLst>
            <pc:docMk/>
            <pc:sldMk cId="1587328182" sldId="256"/>
            <ac:spMk id="7" creationId="{B6EC19E4-DC0B-FFA1-43F1-4592EB8F0658}"/>
          </ac:spMkLst>
        </pc:spChg>
        <pc:spChg chg="del">
          <ac:chgData name="Christian Gourdeau" userId="3ac40c24-6cc4-4d51-8833-f135e277a828" providerId="ADAL" clId="{8B93CD47-A855-419C-90B7-815DDE89D493}" dt="2026-01-07T17:58:41.482" v="50" actId="478"/>
          <ac:spMkLst>
            <pc:docMk/>
            <pc:sldMk cId="1587328182" sldId="256"/>
            <ac:spMk id="8" creationId="{EEFCE56C-D81F-F08B-9C5D-0C7BD22C8200}"/>
          </ac:spMkLst>
        </pc:spChg>
        <pc:spChg chg="add mod ord">
          <ac:chgData name="Christian Gourdeau" userId="3ac40c24-6cc4-4d51-8833-f135e277a828" providerId="ADAL" clId="{8B93CD47-A855-419C-90B7-815DDE89D493}" dt="2026-01-07T18:32:54.709" v="169" actId="1035"/>
          <ac:spMkLst>
            <pc:docMk/>
            <pc:sldMk cId="1587328182" sldId="256"/>
            <ac:spMk id="11" creationId="{795EABDF-EABE-AEEF-3E37-21FB1BB2B403}"/>
          </ac:spMkLst>
        </pc:spChg>
        <pc:spChg chg="add mod">
          <ac:chgData name="Christian Gourdeau" userId="3ac40c24-6cc4-4d51-8833-f135e277a828" providerId="ADAL" clId="{8B93CD47-A855-419C-90B7-815DDE89D493}" dt="2026-01-07T18:32:54.709" v="169" actId="1035"/>
          <ac:spMkLst>
            <pc:docMk/>
            <pc:sldMk cId="1587328182" sldId="256"/>
            <ac:spMk id="12" creationId="{5D94BA4E-E939-58AA-7E17-0439F1773A2D}"/>
          </ac:spMkLst>
        </pc:spChg>
        <pc:picChg chg="del">
          <ac:chgData name="Christian Gourdeau" userId="3ac40c24-6cc4-4d51-8833-f135e277a828" providerId="ADAL" clId="{8B93CD47-A855-419C-90B7-815DDE89D493}" dt="2026-01-07T17:48:02.609" v="0" actId="478"/>
          <ac:picMkLst>
            <pc:docMk/>
            <pc:sldMk cId="1587328182" sldId="256"/>
            <ac:picMk id="4" creationId="{A842863C-A812-329A-2692-A23104120BD7}"/>
          </ac:picMkLst>
        </pc:picChg>
        <pc:picChg chg="add mod">
          <ac:chgData name="Christian Gourdeau" userId="3ac40c24-6cc4-4d51-8833-f135e277a828" providerId="ADAL" clId="{8B93CD47-A855-419C-90B7-815DDE89D493}" dt="2026-01-07T18:32:54.709" v="169" actId="1035"/>
          <ac:picMkLst>
            <pc:docMk/>
            <pc:sldMk cId="1587328182" sldId="256"/>
            <ac:picMk id="9" creationId="{E00FB0E3-C069-6996-540F-F0F0999B1C96}"/>
          </ac:picMkLst>
        </pc:picChg>
      </pc:sldChg>
      <pc:sldChg chg="addSp delSp modSp add del mod">
        <pc:chgData name="Christian Gourdeau" userId="3ac40c24-6cc4-4d51-8833-f135e277a828" providerId="ADAL" clId="{8B93CD47-A855-419C-90B7-815DDE89D493}" dt="2026-01-07T18:27:57.612" v="102" actId="166"/>
        <pc:sldMkLst>
          <pc:docMk/>
          <pc:sldMk cId="813471439" sldId="257"/>
        </pc:sldMkLst>
        <pc:spChg chg="add mod">
          <ac:chgData name="Christian Gourdeau" userId="3ac40c24-6cc4-4d51-8833-f135e277a828" providerId="ADAL" clId="{8B93CD47-A855-419C-90B7-815DDE89D493}" dt="2026-01-07T18:27:47.203" v="100" actId="1036"/>
          <ac:spMkLst>
            <pc:docMk/>
            <pc:sldMk cId="813471439" sldId="257"/>
            <ac:spMk id="5" creationId="{62FD2393-DF49-20E5-792A-F8FA6C5A4A37}"/>
          </ac:spMkLst>
        </pc:spChg>
        <pc:spChg chg="del">
          <ac:chgData name="Christian Gourdeau" userId="3ac40c24-6cc4-4d51-8833-f135e277a828" providerId="ADAL" clId="{8B93CD47-A855-419C-90B7-815DDE89D493}" dt="2026-01-07T17:52:14.371" v="11" actId="478"/>
          <ac:spMkLst>
            <pc:docMk/>
            <pc:sldMk cId="813471439" sldId="257"/>
            <ac:spMk id="7" creationId="{829832D8-79D4-32F8-22FC-D788066F9E1E}"/>
          </ac:spMkLst>
        </pc:spChg>
        <pc:spChg chg="del">
          <ac:chgData name="Christian Gourdeau" userId="3ac40c24-6cc4-4d51-8833-f135e277a828" providerId="ADAL" clId="{8B93CD47-A855-419C-90B7-815DDE89D493}" dt="2026-01-07T17:52:14.371" v="11" actId="478"/>
          <ac:spMkLst>
            <pc:docMk/>
            <pc:sldMk cId="813471439" sldId="257"/>
            <ac:spMk id="8" creationId="{4DF7C2A8-DB08-3752-5E94-656B1D014366}"/>
          </ac:spMkLst>
        </pc:spChg>
        <pc:spChg chg="add mod ord">
          <ac:chgData name="Christian Gourdeau" userId="3ac40c24-6cc4-4d51-8833-f135e277a828" providerId="ADAL" clId="{8B93CD47-A855-419C-90B7-815DDE89D493}" dt="2026-01-07T18:27:57.612" v="102" actId="166"/>
          <ac:spMkLst>
            <pc:docMk/>
            <pc:sldMk cId="813471439" sldId="257"/>
            <ac:spMk id="9" creationId="{4479C7BA-3F92-29D7-6ECD-4A1A69169358}"/>
          </ac:spMkLst>
        </pc:spChg>
        <pc:picChg chg="del">
          <ac:chgData name="Christian Gourdeau" userId="3ac40c24-6cc4-4d51-8833-f135e277a828" providerId="ADAL" clId="{8B93CD47-A855-419C-90B7-815DDE89D493}" dt="2026-01-07T17:52:05.216" v="10" actId="478"/>
          <ac:picMkLst>
            <pc:docMk/>
            <pc:sldMk cId="813471439" sldId="257"/>
            <ac:picMk id="2" creationId="{BF1AE0A4-C595-AF07-7181-1C746BC6BFFF}"/>
          </ac:picMkLst>
        </pc:picChg>
        <pc:picChg chg="add mod">
          <ac:chgData name="Christian Gourdeau" userId="3ac40c24-6cc4-4d51-8833-f135e277a828" providerId="ADAL" clId="{8B93CD47-A855-419C-90B7-815DDE89D493}" dt="2026-01-07T17:53:12.869" v="17" actId="1076"/>
          <ac:picMkLst>
            <pc:docMk/>
            <pc:sldMk cId="813471439" sldId="257"/>
            <ac:picMk id="4" creationId="{2D29FC8A-5183-378A-E19F-361026D69055}"/>
          </ac:picMkLst>
        </pc:picChg>
      </pc:sldChg>
      <pc:sldChg chg="addSp delSp modSp mod">
        <pc:chgData name="Christian Gourdeau" userId="3ac40c24-6cc4-4d51-8833-f135e277a828" providerId="ADAL" clId="{8B93CD47-A855-419C-90B7-815DDE89D493}" dt="2026-01-07T18:26:49.450" v="92" actId="1076"/>
        <pc:sldMkLst>
          <pc:docMk/>
          <pc:sldMk cId="1947382374" sldId="258"/>
        </pc:sldMkLst>
        <pc:spChg chg="add mod">
          <ac:chgData name="Christian Gourdeau" userId="3ac40c24-6cc4-4d51-8833-f135e277a828" providerId="ADAL" clId="{8B93CD47-A855-419C-90B7-815DDE89D493}" dt="2026-01-07T18:25:16.634" v="70" actId="1036"/>
          <ac:spMkLst>
            <pc:docMk/>
            <pc:sldMk cId="1947382374" sldId="258"/>
            <ac:spMk id="5" creationId="{A2271E8E-2EEF-9F3F-C1F1-892858A6A2BD}"/>
          </ac:spMkLst>
        </pc:spChg>
        <pc:spChg chg="del mod">
          <ac:chgData name="Christian Gourdeau" userId="3ac40c24-6cc4-4d51-8833-f135e277a828" providerId="ADAL" clId="{8B93CD47-A855-419C-90B7-815DDE89D493}" dt="2026-01-07T17:53:29.787" v="20" actId="478"/>
          <ac:spMkLst>
            <pc:docMk/>
            <pc:sldMk cId="1947382374" sldId="258"/>
            <ac:spMk id="7" creationId="{5B84025D-AE0D-2496-E3A9-DFD0564178FB}"/>
          </ac:spMkLst>
        </pc:spChg>
        <pc:spChg chg="del">
          <ac:chgData name="Christian Gourdeau" userId="3ac40c24-6cc4-4d51-8833-f135e277a828" providerId="ADAL" clId="{8B93CD47-A855-419C-90B7-815DDE89D493}" dt="2026-01-07T17:53:34.261" v="21" actId="478"/>
          <ac:spMkLst>
            <pc:docMk/>
            <pc:sldMk cId="1947382374" sldId="258"/>
            <ac:spMk id="8" creationId="{5E338CD6-F655-3874-DC9C-BB871D1D462F}"/>
          </ac:spMkLst>
        </pc:spChg>
        <pc:spChg chg="add mod">
          <ac:chgData name="Christian Gourdeau" userId="3ac40c24-6cc4-4d51-8833-f135e277a828" providerId="ADAL" clId="{8B93CD47-A855-419C-90B7-815DDE89D493}" dt="2026-01-07T18:26:49.450" v="92" actId="1076"/>
          <ac:spMkLst>
            <pc:docMk/>
            <pc:sldMk cId="1947382374" sldId="258"/>
            <ac:spMk id="9" creationId="{C3F353A8-9524-C625-6291-C16A0E19445B}"/>
          </ac:spMkLst>
        </pc:spChg>
        <pc:picChg chg="add mod">
          <ac:chgData name="Christian Gourdeau" userId="3ac40c24-6cc4-4d51-8833-f135e277a828" providerId="ADAL" clId="{8B93CD47-A855-419C-90B7-815DDE89D493}" dt="2026-01-07T17:54:09.912" v="27" actId="1076"/>
          <ac:picMkLst>
            <pc:docMk/>
            <pc:sldMk cId="1947382374" sldId="258"/>
            <ac:picMk id="3" creationId="{E55629CF-6441-E7BA-7C79-0562731F6F02}"/>
          </ac:picMkLst>
        </pc:picChg>
        <pc:picChg chg="del">
          <ac:chgData name="Christian Gourdeau" userId="3ac40c24-6cc4-4d51-8833-f135e277a828" providerId="ADAL" clId="{8B93CD47-A855-419C-90B7-815DDE89D493}" dt="2026-01-07T17:53:25.171" v="18" actId="478"/>
          <ac:picMkLst>
            <pc:docMk/>
            <pc:sldMk cId="1947382374" sldId="258"/>
            <ac:picMk id="4" creationId="{A8A590D8-006D-6F99-6BFE-2709F4986AC7}"/>
          </ac:picMkLst>
        </pc:picChg>
      </pc:sldChg>
      <pc:sldChg chg="addSp delSp modSp mod">
        <pc:chgData name="Christian Gourdeau" userId="3ac40c24-6cc4-4d51-8833-f135e277a828" providerId="ADAL" clId="{8B93CD47-A855-419C-90B7-815DDE89D493}" dt="2026-01-07T18:28:37.399" v="115" actId="166"/>
        <pc:sldMkLst>
          <pc:docMk/>
          <pc:sldMk cId="848870896" sldId="259"/>
        </pc:sldMkLst>
        <pc:spChg chg="add mod">
          <ac:chgData name="Christian Gourdeau" userId="3ac40c24-6cc4-4d51-8833-f135e277a828" providerId="ADAL" clId="{8B93CD47-A855-419C-90B7-815DDE89D493}" dt="2026-01-07T18:28:26.526" v="105" actId="1036"/>
          <ac:spMkLst>
            <pc:docMk/>
            <pc:sldMk cId="848870896" sldId="259"/>
            <ac:spMk id="5" creationId="{87B621AD-0BD3-88AD-BE33-E60811174B52}"/>
          </ac:spMkLst>
        </pc:spChg>
        <pc:spChg chg="del">
          <ac:chgData name="Christian Gourdeau" userId="3ac40c24-6cc4-4d51-8833-f135e277a828" providerId="ADAL" clId="{8B93CD47-A855-419C-90B7-815DDE89D493}" dt="2026-01-07T17:54:30.229" v="29" actId="478"/>
          <ac:spMkLst>
            <pc:docMk/>
            <pc:sldMk cId="848870896" sldId="259"/>
            <ac:spMk id="7" creationId="{DCF68E14-66A7-3FF9-8384-251C1E85FA73}"/>
          </ac:spMkLst>
        </pc:spChg>
        <pc:spChg chg="del">
          <ac:chgData name="Christian Gourdeau" userId="3ac40c24-6cc4-4d51-8833-f135e277a828" providerId="ADAL" clId="{8B93CD47-A855-419C-90B7-815DDE89D493}" dt="2026-01-07T17:55:09.104" v="35" actId="478"/>
          <ac:spMkLst>
            <pc:docMk/>
            <pc:sldMk cId="848870896" sldId="259"/>
            <ac:spMk id="8" creationId="{292597C7-5B2E-90AE-D080-8C16C2335A0E}"/>
          </ac:spMkLst>
        </pc:spChg>
        <pc:spChg chg="add mod ord">
          <ac:chgData name="Christian Gourdeau" userId="3ac40c24-6cc4-4d51-8833-f135e277a828" providerId="ADAL" clId="{8B93CD47-A855-419C-90B7-815DDE89D493}" dt="2026-01-07T18:28:37.399" v="115" actId="166"/>
          <ac:spMkLst>
            <pc:docMk/>
            <pc:sldMk cId="848870896" sldId="259"/>
            <ac:spMk id="9" creationId="{025C7802-CD72-FDE5-1FFD-B804046DD8D9}"/>
          </ac:spMkLst>
        </pc:spChg>
        <pc:picChg chg="del">
          <ac:chgData name="Christian Gourdeau" userId="3ac40c24-6cc4-4d51-8833-f135e277a828" providerId="ADAL" clId="{8B93CD47-A855-419C-90B7-815DDE89D493}" dt="2026-01-07T17:54:26.675" v="28" actId="478"/>
          <ac:picMkLst>
            <pc:docMk/>
            <pc:sldMk cId="848870896" sldId="259"/>
            <ac:picMk id="3" creationId="{13DF658D-6574-9ABF-B9F2-EFBD50990F20}"/>
          </ac:picMkLst>
        </pc:picChg>
        <pc:picChg chg="add mod">
          <ac:chgData name="Christian Gourdeau" userId="3ac40c24-6cc4-4d51-8833-f135e277a828" providerId="ADAL" clId="{8B93CD47-A855-419C-90B7-815DDE89D493}" dt="2026-01-07T17:55:04.388" v="34" actId="1076"/>
          <ac:picMkLst>
            <pc:docMk/>
            <pc:sldMk cId="848870896" sldId="259"/>
            <ac:picMk id="4" creationId="{792846E7-DC04-BCCE-9286-D42FBAC6BA75}"/>
          </ac:picMkLst>
        </pc:picChg>
      </pc:sldChg>
      <pc:sldChg chg="addSp delSp modSp mod">
        <pc:chgData name="Christian Gourdeau" userId="3ac40c24-6cc4-4d51-8833-f135e277a828" providerId="ADAL" clId="{8B93CD47-A855-419C-90B7-815DDE89D493}" dt="2026-01-07T18:27:05.121" v="96" actId="1076"/>
        <pc:sldMkLst>
          <pc:docMk/>
          <pc:sldMk cId="3656259302" sldId="260"/>
        </pc:sldMkLst>
        <pc:spChg chg="add mod">
          <ac:chgData name="Christian Gourdeau" userId="3ac40c24-6cc4-4d51-8833-f135e277a828" providerId="ADAL" clId="{8B93CD47-A855-419C-90B7-815DDE89D493}" dt="2026-01-07T18:25:31.917" v="74" actId="1076"/>
          <ac:spMkLst>
            <pc:docMk/>
            <pc:sldMk cId="3656259302" sldId="260"/>
            <ac:spMk id="5" creationId="{B5C93679-EC6D-0B70-C447-501847979118}"/>
          </ac:spMkLst>
        </pc:spChg>
        <pc:spChg chg="del">
          <ac:chgData name="Christian Gourdeau" userId="3ac40c24-6cc4-4d51-8833-f135e277a828" providerId="ADAL" clId="{8B93CD47-A855-419C-90B7-815DDE89D493}" dt="2026-01-07T17:55:31.596" v="36" actId="478"/>
          <ac:spMkLst>
            <pc:docMk/>
            <pc:sldMk cId="3656259302" sldId="260"/>
            <ac:spMk id="7" creationId="{71FD4A3B-A2DD-5B80-8724-D28EC34C664B}"/>
          </ac:spMkLst>
        </pc:spChg>
        <pc:spChg chg="del">
          <ac:chgData name="Christian Gourdeau" userId="3ac40c24-6cc4-4d51-8833-f135e277a828" providerId="ADAL" clId="{8B93CD47-A855-419C-90B7-815DDE89D493}" dt="2026-01-07T17:55:31.596" v="36" actId="478"/>
          <ac:spMkLst>
            <pc:docMk/>
            <pc:sldMk cId="3656259302" sldId="260"/>
            <ac:spMk id="8" creationId="{91B2E956-6088-6114-4D7C-914823DE58D3}"/>
          </ac:spMkLst>
        </pc:spChg>
        <pc:spChg chg="add mod">
          <ac:chgData name="Christian Gourdeau" userId="3ac40c24-6cc4-4d51-8833-f135e277a828" providerId="ADAL" clId="{8B93CD47-A855-419C-90B7-815DDE89D493}" dt="2026-01-07T18:27:05.121" v="96" actId="1076"/>
          <ac:spMkLst>
            <pc:docMk/>
            <pc:sldMk cId="3656259302" sldId="260"/>
            <ac:spMk id="9" creationId="{846DE152-E037-6CE4-BDAA-11D5557F4C8B}"/>
          </ac:spMkLst>
        </pc:spChg>
        <pc:picChg chg="add mod">
          <ac:chgData name="Christian Gourdeau" userId="3ac40c24-6cc4-4d51-8833-f135e277a828" providerId="ADAL" clId="{8B93CD47-A855-419C-90B7-815DDE89D493}" dt="2026-01-07T17:55:59.614" v="41" actId="1076"/>
          <ac:picMkLst>
            <pc:docMk/>
            <pc:sldMk cId="3656259302" sldId="260"/>
            <ac:picMk id="3" creationId="{CE25E0DF-B76A-7366-C153-2F5F261DA9A8}"/>
          </ac:picMkLst>
        </pc:picChg>
        <pc:picChg chg="del">
          <ac:chgData name="Christian Gourdeau" userId="3ac40c24-6cc4-4d51-8833-f135e277a828" providerId="ADAL" clId="{8B93CD47-A855-419C-90B7-815DDE89D493}" dt="2026-01-07T17:55:31.596" v="36" actId="478"/>
          <ac:picMkLst>
            <pc:docMk/>
            <pc:sldMk cId="3656259302" sldId="260"/>
            <ac:picMk id="4" creationId="{D11B9838-5064-6B8D-AF89-ECC629766290}"/>
          </ac:picMkLst>
        </pc:picChg>
      </pc:sldChg>
      <pc:sldChg chg="addSp delSp modSp add del mod">
        <pc:chgData name="Christian Gourdeau" userId="3ac40c24-6cc4-4d51-8833-f135e277a828" providerId="ADAL" clId="{8B93CD47-A855-419C-90B7-815DDE89D493}" dt="2026-01-07T18:27:08.141" v="97"/>
        <pc:sldMkLst>
          <pc:docMk/>
          <pc:sldMk cId="404655772" sldId="261"/>
        </pc:sldMkLst>
        <pc:spChg chg="add mod">
          <ac:chgData name="Christian Gourdeau" userId="3ac40c24-6cc4-4d51-8833-f135e277a828" providerId="ADAL" clId="{8B93CD47-A855-419C-90B7-815DDE89D493}" dt="2026-01-07T18:25:45.811" v="78" actId="1036"/>
          <ac:spMkLst>
            <pc:docMk/>
            <pc:sldMk cId="404655772" sldId="261"/>
            <ac:spMk id="5" creationId="{6394A268-C020-9B81-D317-4A2D2EA5334F}"/>
          </ac:spMkLst>
        </pc:spChg>
        <pc:spChg chg="del">
          <ac:chgData name="Christian Gourdeau" userId="3ac40c24-6cc4-4d51-8833-f135e277a828" providerId="ADAL" clId="{8B93CD47-A855-419C-90B7-815DDE89D493}" dt="2026-01-07T17:57:13.636" v="44" actId="478"/>
          <ac:spMkLst>
            <pc:docMk/>
            <pc:sldMk cId="404655772" sldId="261"/>
            <ac:spMk id="7" creationId="{A123D24E-53A0-4B11-59BC-BF3FEE16CD8E}"/>
          </ac:spMkLst>
        </pc:spChg>
        <pc:spChg chg="del">
          <ac:chgData name="Christian Gourdeau" userId="3ac40c24-6cc4-4d51-8833-f135e277a828" providerId="ADAL" clId="{8B93CD47-A855-419C-90B7-815DDE89D493}" dt="2026-01-07T17:57:13.636" v="44" actId="478"/>
          <ac:spMkLst>
            <pc:docMk/>
            <pc:sldMk cId="404655772" sldId="261"/>
            <ac:spMk id="8" creationId="{3AE2BF0E-EA6C-8751-E6CD-2D707F59888C}"/>
          </ac:spMkLst>
        </pc:spChg>
        <pc:spChg chg="add mod">
          <ac:chgData name="Christian Gourdeau" userId="3ac40c24-6cc4-4d51-8833-f135e277a828" providerId="ADAL" clId="{8B93CD47-A855-419C-90B7-815DDE89D493}" dt="2026-01-07T18:27:08.141" v="97"/>
          <ac:spMkLst>
            <pc:docMk/>
            <pc:sldMk cId="404655772" sldId="261"/>
            <ac:spMk id="9" creationId="{765619E8-762A-EDD6-7629-03F4F5799BFE}"/>
          </ac:spMkLst>
        </pc:spChg>
        <pc:picChg chg="del">
          <ac:chgData name="Christian Gourdeau" userId="3ac40c24-6cc4-4d51-8833-f135e277a828" providerId="ADAL" clId="{8B93CD47-A855-419C-90B7-815DDE89D493}" dt="2026-01-07T17:57:13.636" v="44" actId="478"/>
          <ac:picMkLst>
            <pc:docMk/>
            <pc:sldMk cId="404655772" sldId="261"/>
            <ac:picMk id="3" creationId="{5FCC4790-4C4D-B634-133E-771AE55A6696}"/>
          </ac:picMkLst>
        </pc:picChg>
        <pc:picChg chg="add mod">
          <ac:chgData name="Christian Gourdeau" userId="3ac40c24-6cc4-4d51-8833-f135e277a828" providerId="ADAL" clId="{8B93CD47-A855-419C-90B7-815DDE89D493}" dt="2026-01-07T17:57:46.803" v="49" actId="1076"/>
          <ac:picMkLst>
            <pc:docMk/>
            <pc:sldMk cId="404655772" sldId="261"/>
            <ac:picMk id="4" creationId="{E5874003-B9AD-9B8E-7424-D18E030DA7A1}"/>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41103458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508789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31899943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5180167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7899955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5BA072F4-4211-4799-96A4-4A31DCE98626}" type="datetimeFigureOut">
              <a:rPr lang="fr-CA" smtClean="0"/>
              <a:t>2026-01-13</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16009570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340100"/>
            <a:ext cx="2901255" cy="4912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340100"/>
            <a:ext cx="2915543" cy="4912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5BA072F4-4211-4799-96A4-4A31DCE98626}" type="datetimeFigureOut">
              <a:rPr lang="fr-CA" smtClean="0"/>
              <a:t>2026-01-13</a:t>
            </a:fld>
            <a:endParaRPr lang="fr-CA"/>
          </a:p>
        </p:txBody>
      </p:sp>
      <p:sp>
        <p:nvSpPr>
          <p:cNvPr id="8" name="Footer Placeholder 7"/>
          <p:cNvSpPr>
            <a:spLocks noGrp="1"/>
          </p:cNvSpPr>
          <p:nvPr>
            <p:ph type="ftr" sz="quarter" idx="11"/>
          </p:nvPr>
        </p:nvSpPr>
        <p:spPr/>
        <p:txBody>
          <a:bodyPr/>
          <a:lstStyle/>
          <a:p>
            <a:endParaRPr lang="fr-CA"/>
          </a:p>
        </p:txBody>
      </p:sp>
      <p:sp>
        <p:nvSpPr>
          <p:cNvPr id="9" name="Slide Number Placeholder 8"/>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6571522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5BA072F4-4211-4799-96A4-4A31DCE98626}" type="datetimeFigureOut">
              <a:rPr lang="fr-CA" smtClean="0"/>
              <a:t>2026-01-13</a:t>
            </a:fld>
            <a:endParaRPr lang="fr-CA"/>
          </a:p>
        </p:txBody>
      </p:sp>
      <p:sp>
        <p:nvSpPr>
          <p:cNvPr id="4" name="Footer Placeholder 3"/>
          <p:cNvSpPr>
            <a:spLocks noGrp="1"/>
          </p:cNvSpPr>
          <p:nvPr>
            <p:ph type="ftr" sz="quarter" idx="11"/>
          </p:nvPr>
        </p:nvSpPr>
        <p:spPr/>
        <p:txBody>
          <a:bodyPr/>
          <a:lstStyle/>
          <a:p>
            <a:endParaRPr lang="fr-CA"/>
          </a:p>
        </p:txBody>
      </p:sp>
      <p:sp>
        <p:nvSpPr>
          <p:cNvPr id="5" name="Slide Number Placeholder 4"/>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41063097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A072F4-4211-4799-96A4-4A31DCE98626}" type="datetimeFigureOut">
              <a:rPr lang="fr-CA" smtClean="0"/>
              <a:t>2026-01-13</a:t>
            </a:fld>
            <a:endParaRPr lang="fr-CA"/>
          </a:p>
        </p:txBody>
      </p:sp>
      <p:sp>
        <p:nvSpPr>
          <p:cNvPr id="3" name="Footer Placeholder 2"/>
          <p:cNvSpPr>
            <a:spLocks noGrp="1"/>
          </p:cNvSpPr>
          <p:nvPr>
            <p:ph type="ftr" sz="quarter" idx="11"/>
          </p:nvPr>
        </p:nvSpPr>
        <p:spPr/>
        <p:txBody>
          <a:bodyPr/>
          <a:lstStyle/>
          <a:p>
            <a:endParaRPr lang="fr-CA"/>
          </a:p>
        </p:txBody>
      </p:sp>
      <p:sp>
        <p:nvSpPr>
          <p:cNvPr id="4" name="Slide Number Placeholder 3"/>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30810570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5BA072F4-4211-4799-96A4-4A31DCE98626}" type="datetimeFigureOut">
              <a:rPr lang="fr-CA" smtClean="0"/>
              <a:t>2026-01-13</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14252988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5BA072F4-4211-4799-96A4-4A31DCE98626}" type="datetimeFigureOut">
              <a:rPr lang="fr-CA" smtClean="0"/>
              <a:t>2026-01-13</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14345690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5BA072F4-4211-4799-96A4-4A31DCE98626}" type="datetimeFigureOut">
              <a:rPr lang="fr-CA" smtClean="0"/>
              <a:t>2026-01-13</a:t>
            </a:fld>
            <a:endParaRPr lang="fr-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fr-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7E7E85B3-B8CD-4C29-AEA9-9FB0755B1C66}" type="slidenum">
              <a:rPr lang="fr-CA" smtClean="0"/>
              <a:t>‹N°›</a:t>
            </a:fld>
            <a:endParaRPr lang="fr-CA"/>
          </a:p>
        </p:txBody>
      </p:sp>
    </p:spTree>
    <p:extLst>
      <p:ext uri="{BB962C8B-B14F-4D97-AF65-F5344CB8AC3E}">
        <p14:creationId xmlns:p14="http://schemas.microsoft.com/office/powerpoint/2010/main" val="47906021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5D94BA4E-E939-58AA-7E17-0439F1773A2D}"/>
              </a:ext>
            </a:extLst>
          </p:cNvPr>
          <p:cNvSpPr/>
          <p:nvPr/>
        </p:nvSpPr>
        <p:spPr>
          <a:xfrm>
            <a:off x="2488557" y="4373731"/>
            <a:ext cx="2106592" cy="18487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CA"/>
          </a:p>
        </p:txBody>
      </p:sp>
      <p:sp>
        <p:nvSpPr>
          <p:cNvPr id="3" name="ZoneTexte 2">
            <a:extLst>
              <a:ext uri="{FF2B5EF4-FFF2-40B4-BE49-F238E27FC236}">
                <a16:creationId xmlns:a16="http://schemas.microsoft.com/office/drawing/2014/main" id="{D87B4501-D7BF-A9EB-E9F7-5BA320F08A2A}"/>
              </a:ext>
            </a:extLst>
          </p:cNvPr>
          <p:cNvSpPr txBox="1"/>
          <p:nvPr/>
        </p:nvSpPr>
        <p:spPr>
          <a:xfrm>
            <a:off x="112853" y="1425933"/>
            <a:ext cx="6511209" cy="1569660"/>
          </a:xfrm>
          <a:prstGeom prst="rect">
            <a:avLst/>
          </a:prstGeom>
          <a:noFill/>
        </p:spPr>
        <p:txBody>
          <a:bodyPr wrap="square">
            <a:spAutoFit/>
          </a:bodyPr>
          <a:lstStyle/>
          <a:p>
            <a:pPr algn="just"/>
            <a:r>
              <a:rPr lang="en-US" sz="1200" dirty="0">
                <a:latin typeface="Times New Roman" panose="02020603050405020304" pitchFamily="18" charset="0"/>
                <a:cs typeface="Times New Roman" panose="02020603050405020304" pitchFamily="18" charset="0"/>
              </a:rPr>
              <a:t>This supplementary figure presents training and validation log loss curves as a function of the number of trees (boosting rounds) for the </a:t>
            </a:r>
            <a:r>
              <a:rPr lang="en-US" sz="1200" dirty="0" err="1">
                <a:latin typeface="Times New Roman" panose="02020603050405020304" pitchFamily="18" charset="0"/>
                <a:cs typeface="Times New Roman" panose="02020603050405020304" pitchFamily="18" charset="0"/>
              </a:rPr>
              <a:t>XGBoost</a:t>
            </a:r>
            <a:r>
              <a:rPr lang="en-US" sz="1200" dirty="0">
                <a:latin typeface="Times New Roman" panose="02020603050405020304" pitchFamily="18" charset="0"/>
                <a:cs typeface="Times New Roman" panose="02020603050405020304" pitchFamily="18" charset="0"/>
              </a:rPr>
              <a:t> model across all binary classification tasks evaluated in the study. Panels include the distinction between cognitively normal individuals and cognitively impaired participants, as well as one-vs-rest classifications for individual dementia subtypes (Alzheimer’s disease, vascular dementia, Lewy body dementia, behavioral variant frontotemporal dementia, and primary progressive aphasia). These curves illustrate model convergence behavior, support the selection of the number of boosting rounds, and allow visual assessment of training stability and potential overfitting.</a:t>
            </a:r>
            <a:endParaRPr lang="fr-CA" sz="1200" dirty="0">
              <a:latin typeface="Times New Roman" panose="02020603050405020304" pitchFamily="18" charset="0"/>
              <a:cs typeface="Times New Roman" panose="02020603050405020304" pitchFamily="18" charset="0"/>
            </a:endParaRPr>
          </a:p>
        </p:txBody>
      </p:sp>
      <p:sp>
        <p:nvSpPr>
          <p:cNvPr id="5" name="ZoneTexte 4">
            <a:extLst>
              <a:ext uri="{FF2B5EF4-FFF2-40B4-BE49-F238E27FC236}">
                <a16:creationId xmlns:a16="http://schemas.microsoft.com/office/drawing/2014/main" id="{9CF90590-1DDF-739A-1C66-9C954959BA84}"/>
              </a:ext>
            </a:extLst>
          </p:cNvPr>
          <p:cNvSpPr txBox="1"/>
          <p:nvPr/>
        </p:nvSpPr>
        <p:spPr>
          <a:xfrm>
            <a:off x="112852" y="282071"/>
            <a:ext cx="6632294" cy="646331"/>
          </a:xfrm>
          <a:prstGeom prst="rect">
            <a:avLst/>
          </a:prstGeom>
          <a:noFill/>
        </p:spPr>
        <p:txBody>
          <a:bodyPr wrap="square">
            <a:spAutoFit/>
          </a:bodyPr>
          <a:lstStyle/>
          <a:p>
            <a:r>
              <a:rPr lang="en-US" dirty="0">
                <a:latin typeface="Times New Roman" panose="02020603050405020304" pitchFamily="18" charset="0"/>
                <a:cs typeface="Times New Roman" panose="02020603050405020304" pitchFamily="18" charset="0"/>
              </a:rPr>
              <a:t>Supplementary </a:t>
            </a:r>
            <a:r>
              <a:rPr lang="en-US" dirty="0" smtClean="0">
                <a:latin typeface="Times New Roman" panose="02020603050405020304" pitchFamily="18" charset="0"/>
                <a:cs typeface="Times New Roman" panose="02020603050405020304" pitchFamily="18" charset="0"/>
              </a:rPr>
              <a:t>Table 2. Training </a:t>
            </a:r>
            <a:r>
              <a:rPr lang="en-US" dirty="0">
                <a:latin typeface="Times New Roman" panose="02020603050405020304" pitchFamily="18" charset="0"/>
                <a:cs typeface="Times New Roman" panose="02020603050405020304" pitchFamily="18" charset="0"/>
              </a:rPr>
              <a:t>and validation log loss convergence curves for </a:t>
            </a:r>
            <a:r>
              <a:rPr lang="en-US" dirty="0" err="1">
                <a:latin typeface="Times New Roman" panose="02020603050405020304" pitchFamily="18" charset="0"/>
                <a:cs typeface="Times New Roman" panose="02020603050405020304" pitchFamily="18" charset="0"/>
              </a:rPr>
              <a:t>XGBoost</a:t>
            </a:r>
            <a:r>
              <a:rPr lang="en-US" dirty="0">
                <a:latin typeface="Times New Roman" panose="02020603050405020304" pitchFamily="18" charset="0"/>
                <a:cs typeface="Times New Roman" panose="02020603050405020304" pitchFamily="18" charset="0"/>
              </a:rPr>
              <a:t> across all classification </a:t>
            </a:r>
            <a:r>
              <a:rPr lang="en-US" dirty="0" smtClean="0">
                <a:latin typeface="Times New Roman" panose="02020603050405020304" pitchFamily="18" charset="0"/>
                <a:cs typeface="Times New Roman" panose="02020603050405020304" pitchFamily="18" charset="0"/>
              </a:rPr>
              <a:t>tasks.</a:t>
            </a:r>
            <a:endParaRPr lang="fr-CA" dirty="0">
              <a:latin typeface="Times New Roman" panose="02020603050405020304" pitchFamily="18" charset="0"/>
              <a:cs typeface="Times New Roman" panose="02020603050405020304" pitchFamily="18" charset="0"/>
            </a:endParaRPr>
          </a:p>
        </p:txBody>
      </p:sp>
      <p:pic>
        <p:nvPicPr>
          <p:cNvPr id="4" name="Image 3">
            <a:extLst>
              <a:ext uri="{FF2B5EF4-FFF2-40B4-BE49-F238E27FC236}">
                <a16:creationId xmlns:a16="http://schemas.microsoft.com/office/drawing/2014/main" id="{ECCAE4E1-872C-8C35-96D5-C16060AE47A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8457" y="3772773"/>
            <a:ext cx="5040000" cy="3545043"/>
          </a:xfrm>
          <a:prstGeom prst="rect">
            <a:avLst/>
          </a:prstGeom>
        </p:spPr>
      </p:pic>
    </p:spTree>
    <p:extLst>
      <p:ext uri="{BB962C8B-B14F-4D97-AF65-F5344CB8AC3E}">
        <p14:creationId xmlns:p14="http://schemas.microsoft.com/office/powerpoint/2010/main" val="15873281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0713579C-8DD2-E468-C396-5EFB3F9412B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09000" y="447683"/>
            <a:ext cx="5040000" cy="3545043"/>
          </a:xfrm>
          <a:prstGeom prst="rect">
            <a:avLst/>
          </a:prstGeom>
        </p:spPr>
      </p:pic>
      <p:pic>
        <p:nvPicPr>
          <p:cNvPr id="7" name="Image 6">
            <a:extLst>
              <a:ext uri="{FF2B5EF4-FFF2-40B4-BE49-F238E27FC236}">
                <a16:creationId xmlns:a16="http://schemas.microsoft.com/office/drawing/2014/main" id="{6296D3A5-8FAF-FD16-A1AA-2357A7AFEFD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09000" y="4211782"/>
            <a:ext cx="5040000" cy="3474546"/>
          </a:xfrm>
          <a:prstGeom prst="rect">
            <a:avLst/>
          </a:prstGeom>
        </p:spPr>
      </p:pic>
    </p:spTree>
    <p:extLst>
      <p:ext uri="{BB962C8B-B14F-4D97-AF65-F5344CB8AC3E}">
        <p14:creationId xmlns:p14="http://schemas.microsoft.com/office/powerpoint/2010/main" val="31349194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 8">
            <a:extLst>
              <a:ext uri="{FF2B5EF4-FFF2-40B4-BE49-F238E27FC236}">
                <a16:creationId xmlns:a16="http://schemas.microsoft.com/office/drawing/2014/main" id="{C92256D9-C6B0-754D-AFB6-B0499BDF3B9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09000" y="451848"/>
            <a:ext cx="5040000" cy="3514483"/>
          </a:xfrm>
          <a:prstGeom prst="rect">
            <a:avLst/>
          </a:prstGeom>
        </p:spPr>
      </p:pic>
      <p:pic>
        <p:nvPicPr>
          <p:cNvPr id="11" name="Image 10">
            <a:extLst>
              <a:ext uri="{FF2B5EF4-FFF2-40B4-BE49-F238E27FC236}">
                <a16:creationId xmlns:a16="http://schemas.microsoft.com/office/drawing/2014/main" id="{B89DE709-63A7-1DAD-B08F-05BE8DD4A69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09000" y="3918066"/>
            <a:ext cx="5040000" cy="3545043"/>
          </a:xfrm>
          <a:prstGeom prst="rect">
            <a:avLst/>
          </a:prstGeom>
        </p:spPr>
      </p:pic>
    </p:spTree>
    <p:extLst>
      <p:ext uri="{BB962C8B-B14F-4D97-AF65-F5344CB8AC3E}">
        <p14:creationId xmlns:p14="http://schemas.microsoft.com/office/powerpoint/2010/main" val="6567089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0CB93A93-BF39-DC92-189B-1FD6F46101D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09000" y="2814759"/>
            <a:ext cx="5040000" cy="3514483"/>
          </a:xfrm>
          <a:prstGeom prst="rect">
            <a:avLst/>
          </a:prstGeom>
        </p:spPr>
      </p:pic>
    </p:spTree>
    <p:extLst>
      <p:ext uri="{BB962C8B-B14F-4D97-AF65-F5344CB8AC3E}">
        <p14:creationId xmlns:p14="http://schemas.microsoft.com/office/powerpoint/2010/main" val="1312884430"/>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hèm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8</TotalTime>
  <Words>125</Words>
  <Application>Microsoft Office PowerPoint</Application>
  <PresentationFormat>Affichage à l'écran (4:3)</PresentationFormat>
  <Paragraphs>2</Paragraphs>
  <Slides>4</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4</vt:i4>
      </vt:variant>
    </vt:vector>
  </HeadingPairs>
  <TitlesOfParts>
    <vt:vector size="9" baseType="lpstr">
      <vt:lpstr>Aptos</vt:lpstr>
      <vt:lpstr>Aptos Display</vt:lpstr>
      <vt:lpstr>Arial</vt:lpstr>
      <vt:lpstr>Times New Roman</vt:lpstr>
      <vt:lpstr>Thème Office</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hristian Gourdeau</dc:creator>
  <cp:lastModifiedBy>Robert Laforce</cp:lastModifiedBy>
  <cp:revision>5</cp:revision>
  <dcterms:created xsi:type="dcterms:W3CDTF">2026-01-07T17:22:28Z</dcterms:created>
  <dcterms:modified xsi:type="dcterms:W3CDTF">2026-01-13T21:06:41Z</dcterms:modified>
</cp:coreProperties>
</file>